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363" r:id="rId5"/>
    <p:sldId id="39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940487-C173-6DED-AF85-93F6A0C2C2BA}" name="Ronald Rodriguez" initials="RR" userId="d46245ba6cf3168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68" autoAdjust="0"/>
    <p:restoredTop sz="96338" autoAdjust="0"/>
  </p:normalViewPr>
  <p:slideViewPr>
    <p:cSldViewPr snapToGrid="0">
      <p:cViewPr varScale="1">
        <p:scale>
          <a:sx n="64" d="100"/>
          <a:sy n="64" d="100"/>
        </p:scale>
        <p:origin x="84" y="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E85AE6-0439-456F-BCF6-60B921845DE1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8FFCF8-C588-437B-A32D-4BEEE1BFDC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734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9578B-AA67-4EF9-A0B1-6E122A438C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520BD2-1CAF-42F1-8918-85CEE0B1DD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EFD33-0F6A-4B72-BEB4-A32D7D8B2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3F9BF-1A7A-4AA5-9A00-6AB1C53CA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EC1DE-5FD0-4C84-953C-E3D43C687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969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E5E4E-A9D2-43ED-9B9A-C241296AA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69D6DD-C2F9-43DD-8591-F4E5F18F50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F324B-A686-4838-93D7-6FD251AC0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3FCDC-2858-46F5-A7E9-E9BDE79B6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B4BAF-D444-4770-88BF-34FA7A46D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45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D2217C-DB86-4277-99F2-A4041B7C29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F2384D-D404-47A2-99C0-F91F8CCD01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0781B2-1DDE-4ACF-9D1F-B9E502BE9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D46A4D-A6FF-4EB5-BD5E-869004778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ADF04-02B6-41DC-BC41-97D586F51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20636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ection Divider">
    <p:bg>
      <p:bgPr>
        <a:solidFill>
          <a:schemeClr val="bg1">
            <a:alpha val="37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 userDrawn="1"/>
        </p:nvSpPr>
        <p:spPr>
          <a:xfrm>
            <a:off x="10287001" y="6698816"/>
            <a:ext cx="1904999" cy="13447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b="0" i="0" dirty="0">
              <a:latin typeface="Goudy Oldstyle Std Regular" charset="0"/>
            </a:endParaRP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0" hasCustomPrompt="1"/>
          </p:nvPr>
        </p:nvSpPr>
        <p:spPr>
          <a:xfrm>
            <a:off x="929857" y="753410"/>
            <a:ext cx="9718347" cy="886548"/>
          </a:xfrm>
        </p:spPr>
        <p:txBody>
          <a:bodyPr anchor="b" anchorCtr="0">
            <a:no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330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insert Chart Titl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91B2BED-9056-4EE4-A092-C7768A3F74F0}"/>
              </a:ext>
            </a:extLst>
          </p:cNvPr>
          <p:cNvSpPr/>
          <p:nvPr userDrawn="1"/>
        </p:nvSpPr>
        <p:spPr>
          <a:xfrm>
            <a:off x="-91440" y="-36943"/>
            <a:ext cx="12410902" cy="6966065"/>
          </a:xfrm>
          <a:prstGeom prst="rect">
            <a:avLst/>
          </a:prstGeom>
          <a:solidFill>
            <a:schemeClr val="bg1">
              <a:alpha val="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237491030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C1D6A-CAB5-40D9-AE80-9B862CC5D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0C8D0-B404-4A82-B5D5-AB2FFC8AA6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93BAD-BE77-4B3F-9C9C-7CD463EC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17C72-0340-4BDC-B0B4-D3CE6ABDF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F8136-22A5-4BAE-A424-512DED268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04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61B89-3B8B-4666-9887-6BC4AFF82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88C43F-715F-4485-ADC4-4C045D21FB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716C6-721C-4B43-8DFB-97B84EDE9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0CA836-CE2A-46C8-B010-AA31F56A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0FC0B-50B6-4020-8A2D-5DB054D2C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0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A3AA2-3E78-423D-89BB-71B5B8DF9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F8ED55-7611-4799-81AC-1CE8629397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3AB9FA-D807-4ABB-A33A-6350638842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6BCE4-AD35-41BA-A939-86232EEBA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1E7235-5F39-4475-A713-920C683AF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FA16D1-A635-429C-9248-9EA64B3B4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16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37716-D3B5-42F7-991B-71BC7E50C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8D22BB-F132-41CF-B36E-152C095C3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421EA5-7C57-4D55-A969-68167D78D7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BA4A92-AFB7-440C-A43E-9148BC17D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2F270C-8035-4B50-AE9D-83144B782B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96D18D-03BE-4887-BBB0-BCAAEEB2D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C6A0CC-7F50-428D-AAE2-9DD79A8E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503B97-1F72-4A04-ADA6-36E3499B3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46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1CC94-91F3-42B7-A101-6C2143C63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D4368F-8853-4AD3-BF30-AC3BBE9DB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ECA4CE-87C9-4E0C-B8C5-6A4FA9E17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B375C-40BC-4525-B92B-9F40EBE41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90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5DF131-40A4-4065-B64D-396A85521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B191CD-BAF9-424A-9F6B-74323C23E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414724-62E6-4A68-B98B-71E577261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5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28E29-8C8A-47C3-A687-1EBCDBA63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0CBE6D-3C41-4731-A7D5-75FD1E8FE7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7751D9-B22D-4539-9879-3EC6933EC0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55650-F692-410F-B00C-C340780AE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C43FFD-B963-482F-B3BB-78324A195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2A100E-2BA2-44DE-9490-E304BB1B9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4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45E46-FB78-4CE3-9D75-A0FEF73114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F0F3D6-C0AF-489F-9297-C30CA8EF66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20BD96-27BF-4803-ACBC-05A1E75F31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64186C-52B5-4F9B-8F71-5C416C245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0FDE7E-351F-4B90-9C24-782EDB2EF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22367A-F8DE-4CA2-B00E-3A5E00EA7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71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9A091F-9661-4364-B04B-B914ABFE9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3C6618-FD82-49BD-B945-CA8E0CC8B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EB97E-39CB-467B-BF23-70D2784F18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5B698-67C5-46B1-A5AC-77C51C21E896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C53AC-0B3A-4181-899B-2E855ABC97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4A5BB-2E07-4956-AD29-B1C6C40AE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D107F-64AA-486D-B6B0-4A9758B4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570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49FAD4A-ED00-4704-87C1-F23421368F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9175104"/>
              </p:ext>
            </p:extLst>
          </p:nvPr>
        </p:nvGraphicFramePr>
        <p:xfrm>
          <a:off x="1172103" y="764499"/>
          <a:ext cx="3629852" cy="352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527793" imgH="2453009" progId="Prism8.Document">
                  <p:embed/>
                </p:oleObj>
              </mc:Choice>
              <mc:Fallback>
                <p:oleObj name="Prism 8" r:id="rId2" imgW="2527793" imgH="2453009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49FAD4A-ED00-4704-87C1-F23421368F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72103" y="764499"/>
                        <a:ext cx="3629852" cy="352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36BA4C00-F663-4DB0-B345-D41BE73DB6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160724"/>
              </p:ext>
            </p:extLst>
          </p:nvPr>
        </p:nvGraphicFramePr>
        <p:xfrm>
          <a:off x="4986070" y="764499"/>
          <a:ext cx="2314173" cy="3239016"/>
        </p:xfrm>
        <a:graphic>
          <a:graphicData uri="http://schemas.openxmlformats.org/drawingml/2006/table">
            <a:tbl>
              <a:tblPr/>
              <a:tblGrid>
                <a:gridCol w="1421564">
                  <a:extLst>
                    <a:ext uri="{9D8B030D-6E8A-4147-A177-3AD203B41FA5}">
                      <a16:colId xmlns:a16="http://schemas.microsoft.com/office/drawing/2014/main" val="4221472334"/>
                    </a:ext>
                  </a:extLst>
                </a:gridCol>
                <a:gridCol w="892609">
                  <a:extLst>
                    <a:ext uri="{9D8B030D-6E8A-4147-A177-3AD203B41FA5}">
                      <a16:colId xmlns:a16="http://schemas.microsoft.com/office/drawing/2014/main" val="1760936113"/>
                    </a:ext>
                  </a:extLst>
                </a:gridCol>
              </a:tblGrid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Number of values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255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894146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395907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Minimum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0.00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7824601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25% Percentile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35.0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074956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Media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59.0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9086215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75% Percentile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79.0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886041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Maximum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190.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0462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Range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190.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602551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2052663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Mea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56.6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516176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Std. Deviatio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31.2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9301508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Std. Error of Mea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0.6168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7837445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6722601"/>
                  </a:ext>
                </a:extLst>
              </a:tr>
              <a:tr h="33702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Coefficient of variation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55.08%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7589416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249701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Skewness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-0.00995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797885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Kurtosis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0" i="0" u="none" strike="noStrike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</a:rPr>
                        <a:t>-0.354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2672988"/>
                  </a:ext>
                </a:extLst>
              </a:tr>
              <a:tr h="1733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7769076"/>
                  </a:ext>
                </a:extLst>
              </a:tr>
            </a:tbl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D639D4A6-C8C6-4A27-9030-229D403C821B}"/>
              </a:ext>
            </a:extLst>
          </p:cNvPr>
          <p:cNvSpPr/>
          <p:nvPr/>
        </p:nvSpPr>
        <p:spPr>
          <a:xfrm>
            <a:off x="9060730" y="5332626"/>
            <a:ext cx="1607270" cy="668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2429935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7">
            <a:extLst>
              <a:ext uri="{FF2B5EF4-FFF2-40B4-BE49-F238E27FC236}">
                <a16:creationId xmlns:a16="http://schemas.microsoft.com/office/drawing/2014/main" id="{D2BDEBFF-A773-5482-6364-8C6525127E5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239291" y="190442"/>
            <a:ext cx="10643567" cy="664911"/>
          </a:xfrm>
        </p:spPr>
        <p:txBody>
          <a:bodyPr/>
          <a:lstStyle/>
          <a:p>
            <a:r>
              <a:rPr lang="en-US" sz="1800" b="1" dirty="0"/>
              <a:t>Table S1</a:t>
            </a:r>
            <a:r>
              <a:rPr lang="en-US" sz="1800" dirty="0"/>
              <a:t>.  Distribution of Serum VPA levels during the second quarter of 2021 as collected by LabCorp, Inc.</a:t>
            </a:r>
          </a:p>
        </p:txBody>
      </p:sp>
    </p:spTree>
    <p:extLst>
      <p:ext uri="{BB962C8B-B14F-4D97-AF65-F5344CB8AC3E}">
        <p14:creationId xmlns:p14="http://schemas.microsoft.com/office/powerpoint/2010/main" val="284186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D7E7BFB616F1640AF8C785F8C3121EC" ma:contentTypeVersion="3" ma:contentTypeDescription="Create a new document." ma:contentTypeScope="" ma:versionID="7d684ee0481be49b70e9daf802370bba">
  <xsd:schema xmlns:xsd="http://www.w3.org/2001/XMLSchema" xmlns:xs="http://www.w3.org/2001/XMLSchema" xmlns:p="http://schemas.microsoft.com/office/2006/metadata/properties" xmlns:ns2="359f2c7a-23e1-4954-80fd-c0b3c38bf32a" targetNamespace="http://schemas.microsoft.com/office/2006/metadata/properties" ma:root="true" ma:fieldsID="7498b748389c12a3e0d90ff5256f0a9c" ns2:_="">
    <xsd:import namespace="359f2c7a-23e1-4954-80fd-c0b3c38bf32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9f2c7a-23e1-4954-80fd-c0b3c38bf32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90C87FD-24A2-4011-A456-B98DFEB1442D}">
  <ds:schemaRefs>
    <ds:schemaRef ds:uri="http://purl.org/dc/terms/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359f2c7a-23e1-4954-80fd-c0b3c38bf32a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CE5618C1-9E0D-42E9-855E-187805BC8980}"/>
</file>

<file path=customXml/itemProps3.xml><?xml version="1.0" encoding="utf-8"?>
<ds:datastoreItem xmlns:ds="http://schemas.openxmlformats.org/officeDocument/2006/customXml" ds:itemID="{32F365F7-0250-4F23-86EC-6E8B7A8F360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407</TotalTime>
  <Words>64</Words>
  <Application>Microsoft Office PowerPoint</Application>
  <PresentationFormat>Widescreen</PresentationFormat>
  <Paragraphs>2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Goudy Oldstyle Std Regular</vt:lpstr>
      <vt:lpstr>Office Theme</vt:lpstr>
      <vt:lpstr>Prism 8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ald Rodriguez</dc:creator>
  <cp:lastModifiedBy>Ronald Rodriguez</cp:lastModifiedBy>
  <cp:revision>40</cp:revision>
  <dcterms:created xsi:type="dcterms:W3CDTF">2023-01-03T19:51:06Z</dcterms:created>
  <dcterms:modified xsi:type="dcterms:W3CDTF">2023-09-01T15:2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D7E7BFB616F1640AF8C785F8C3121EC</vt:lpwstr>
  </property>
</Properties>
</file>